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  <p:sldId id="259" r:id="rId4"/>
    <p:sldId id="260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7778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3978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925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4497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6806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9558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4636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891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754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1284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1173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DBF49-2C59-46BF-B88D-6E8E77BD3D63}" type="datetimeFigureOut">
              <a:rPr lang="zh-CN" altLang="en-US" smtClean="0"/>
              <a:t>2020-11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27B234-9F4B-43D7-8418-B08EF4179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2153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92" t="23896" r="36726" b="21325"/>
          <a:stretch/>
        </p:blipFill>
        <p:spPr>
          <a:xfrm>
            <a:off x="2840035" y="1869144"/>
            <a:ext cx="2697448" cy="32676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70" t="34961" r="34066" b="49230"/>
          <a:stretch/>
        </p:blipFill>
        <p:spPr>
          <a:xfrm>
            <a:off x="2840035" y="5217462"/>
            <a:ext cx="2697448" cy="5513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 rot="-3600000">
            <a:off x="3079377" y="1362991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MSO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 rot="-3600000">
            <a:off x="3561543" y="1434709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 rot="-3600000">
            <a:off x="4023224" y="1439192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 rot="-3600000">
            <a:off x="4468340" y="1389887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 rot="-3600000">
            <a:off x="4994764" y="1421264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N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038138" y="750527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585619" y="3371043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585619" y="5170567"/>
            <a:ext cx="221246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GRB2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315602" y="5339844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2711059" y="549497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80054" y="201705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1d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327570" y="464127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2712151" y="478283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2327567" y="421177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2712148" y="4353338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2327564" y="361601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2712145" y="3757586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2327560" y="328350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2712141" y="342507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2258281" y="2507637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2712137" y="264920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2258279" y="2272105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8" name="直接连接符 27"/>
          <p:cNvCxnSpPr/>
          <p:nvPr/>
        </p:nvCxnSpPr>
        <p:spPr>
          <a:xfrm>
            <a:off x="2712135" y="2413672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2258284" y="275703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2712140" y="289859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48593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/>
          <a:srcRect l="5380" b="2654"/>
          <a:stretch/>
        </p:blipFill>
        <p:spPr>
          <a:xfrm>
            <a:off x="3201239" y="1894914"/>
            <a:ext cx="2233757" cy="25291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1239" y="4504764"/>
            <a:ext cx="2233757" cy="7126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5434996" y="3307977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434996" y="4569621"/>
            <a:ext cx="221246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GRB2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 rot="-3600000">
            <a:off x="3321423" y="1322646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MSO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 rot="-3600000">
            <a:off x="3803589" y="1394364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 rot="-3600000">
            <a:off x="4171141" y="1439188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 rot="-3600000">
            <a:off x="4535575" y="1443671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 rot="-3600000">
            <a:off x="4994764" y="1448154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N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280184" y="710182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689412" y="476579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3084869" y="492092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80054" y="201705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1d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687791" y="454428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3072372" y="468585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2687788" y="411478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3072369" y="4256356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2687785" y="324193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3072366" y="3383506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2687781" y="297870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3072362" y="312027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2618502" y="236909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3072358" y="248294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2618500" y="2175123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8" name="直接连接符 27"/>
          <p:cNvCxnSpPr/>
          <p:nvPr/>
        </p:nvCxnSpPr>
        <p:spPr>
          <a:xfrm>
            <a:off x="3072356" y="231669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2618505" y="2660048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3072361" y="280161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46797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80054" y="201705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1d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47" t="16185" r="27507" b="31503"/>
          <a:stretch/>
        </p:blipFill>
        <p:spPr>
          <a:xfrm>
            <a:off x="3200399" y="1896035"/>
            <a:ext cx="2281097" cy="30083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70" t="34849" r="30306" b="52727"/>
          <a:stretch/>
        </p:blipFill>
        <p:spPr>
          <a:xfrm>
            <a:off x="3200399" y="4975409"/>
            <a:ext cx="2281097" cy="6589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2689412" y="522299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3084869" y="5378123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5475337" y="3321424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5515678" y="4959584"/>
            <a:ext cx="221246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GRB2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 rot="-3600000">
            <a:off x="3254188" y="1336093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MSO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 rot="-3600000">
            <a:off x="3736354" y="1407811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 rot="-3600000">
            <a:off x="4103906" y="1452635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 rot="-3600000">
            <a:off x="4468340" y="1457118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 rot="-3600000">
            <a:off x="4927529" y="1461601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N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212949" y="723629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714682" y="426270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6" name="直接连接符 15"/>
          <p:cNvCxnSpPr/>
          <p:nvPr/>
        </p:nvCxnSpPr>
        <p:spPr>
          <a:xfrm>
            <a:off x="3099263" y="4404273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2714679" y="338985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3099260" y="3531423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2714675" y="312662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3099256" y="326818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2645396" y="2517007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3099252" y="263086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2645394" y="232304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3099250" y="246460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2645399" y="2807965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3099255" y="2949532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52757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6949" y="484093"/>
            <a:ext cx="220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8680" y="1912172"/>
            <a:ext cx="4386340" cy="3493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82818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</TotalTime>
  <Words>81</Words>
  <Application>Microsoft Office PowerPoint</Application>
  <PresentationFormat>全屏显示(4:3)</PresentationFormat>
  <Paragraphs>5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2</cp:revision>
  <dcterms:created xsi:type="dcterms:W3CDTF">2020-08-31T02:53:18Z</dcterms:created>
  <dcterms:modified xsi:type="dcterms:W3CDTF">2020-11-16T03:26:13Z</dcterms:modified>
</cp:coreProperties>
</file>